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15AC97-A397-476B-99EC-282CA6A34161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ca-E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A17D45-4F6C-4917-A590-E37A307E86FD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5D63D-F708-4CD6-AA7A-9CEF1D5B83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77BD81-4BD3-4DED-B03D-B3DEAA7DDE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EDF78D-231D-4C9B-BC5E-619B0D6E98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AB1F7-938B-4CCD-8B07-84E8349EDF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98F5C-4850-46E1-B064-C0601DC198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A52BE7-BB53-477B-80CC-EA4841DFAD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9FAEA-B7B4-4BE9-B86A-1A4F5FDF65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38C8A-D24A-4F96-8C27-1128049311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B9166-B1B2-419F-ACED-9C6812F872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0A24B-0382-4780-AF1C-73C00D23E7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119AC4-32C9-45F5-A235-FE38CD5E56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AAD43-FD71-4659-8469-E15EB884D6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39E896-D094-4182-8D4B-DD9AEFF76FEB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330 CuadroTexto"/>
          <p:cNvSpPr/>
          <p:nvPr/>
        </p:nvSpPr>
        <p:spPr>
          <a:xfrm>
            <a:off x="7429680" y="3476520"/>
            <a:ext cx="59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0000"/>
                </a:solidFill>
                <a:latin typeface="Calibri"/>
              </a:rPr>
              <a:t>L-C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330 CuadroTexto"/>
          <p:cNvSpPr/>
          <p:nvPr/>
        </p:nvSpPr>
        <p:spPr>
          <a:xfrm>
            <a:off x="6278400" y="3476520"/>
            <a:ext cx="478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acS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330 CuadroTexto"/>
          <p:cNvSpPr/>
          <p:nvPr/>
        </p:nvSpPr>
        <p:spPr>
          <a:xfrm>
            <a:off x="6539040" y="3068640"/>
            <a:ext cx="477720" cy="20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Calibri"/>
              </a:rPr>
              <a:t>H</a:t>
            </a:r>
            <a:r>
              <a:rPr b="1" lang="en-US" sz="1200" spc="-1" strike="noStrike" baseline="-25000">
                <a:solidFill>
                  <a:srgbClr val="ff0000"/>
                </a:solidFill>
                <a:latin typeface="Calibri"/>
              </a:rPr>
              <a:t>2</a:t>
            </a:r>
            <a:r>
              <a:rPr b="1" lang="en-US" sz="1200" spc="-1" strike="noStrike">
                <a:solidFill>
                  <a:srgbClr val="ff0000"/>
                </a:solidFill>
                <a:latin typeface="Calibri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330 CuadroTexto"/>
          <p:cNvSpPr/>
          <p:nvPr/>
        </p:nvSpPr>
        <p:spPr>
          <a:xfrm>
            <a:off x="7115040" y="3027240"/>
            <a:ext cx="478080" cy="50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acetate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1" lang="es-ES" sz="1100" spc="-1" strike="noStrike" baseline="30000">
                <a:solidFill>
                  <a:srgbClr val="000000"/>
                </a:solidFill>
                <a:latin typeface="Calibri"/>
              </a:rPr>
              <a:t>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330 CuadroTexto"/>
          <p:cNvSpPr/>
          <p:nvPr/>
        </p:nvSpPr>
        <p:spPr>
          <a:xfrm>
            <a:off x="4968720" y="3476520"/>
            <a:ext cx="344520" cy="19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O</a:t>
            </a:r>
            <a:r>
              <a:rPr b="1" lang="en-US" sz="1100" spc="-1" strike="noStrike" baseline="-25000">
                <a:solidFill>
                  <a:srgbClr val="000000"/>
                </a:solidFill>
                <a:latin typeface="Calibri"/>
              </a:rPr>
              <a:t>3</a:t>
            </a:r>
            <a:r>
              <a:rPr b="1" lang="en-US" sz="1100" spc="-1" strike="noStrike" baseline="30000">
                <a:solidFill>
                  <a:srgbClr val="000000"/>
                </a:solidFill>
                <a:latin typeface="Calibri"/>
              </a:rPr>
              <a:t>2-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" name="49 Conector recto de flecha"/>
          <p:cNvCxnSpPr/>
          <p:nvPr/>
        </p:nvCxnSpPr>
        <p:spPr>
          <a:xfrm>
            <a:off x="4000680" y="3571560"/>
            <a:ext cx="900720" cy="39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sm"/>
          </a:ln>
        </p:spPr>
      </p:cxnSp>
      <p:sp>
        <p:nvSpPr>
          <p:cNvPr id="54" name="194 Rectángulo"/>
          <p:cNvSpPr/>
          <p:nvPr/>
        </p:nvSpPr>
        <p:spPr>
          <a:xfrm>
            <a:off x="3762360" y="3575160"/>
            <a:ext cx="13096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100" spc="-1" strike="noStrike">
                <a:solidFill>
                  <a:srgbClr val="00b0f0"/>
                </a:solidFill>
                <a:latin typeface="Calibri"/>
              </a:rPr>
              <a:t>cys</a:t>
            </a:r>
            <a:r>
              <a:rPr b="1" lang="es-ES" sz="1100" spc="-1" strike="noStrike">
                <a:solidFill>
                  <a:srgbClr val="00b0f0"/>
                </a:solidFill>
                <a:latin typeface="Calibri"/>
              </a:rPr>
              <a:t>H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330 CuadroTexto"/>
          <p:cNvSpPr/>
          <p:nvPr/>
        </p:nvSpPr>
        <p:spPr>
          <a:xfrm>
            <a:off x="3641760" y="3476520"/>
            <a:ext cx="474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PAP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330 CuadroTexto"/>
          <p:cNvSpPr/>
          <p:nvPr/>
        </p:nvSpPr>
        <p:spPr>
          <a:xfrm>
            <a:off x="4597560" y="3116160"/>
            <a:ext cx="474480" cy="19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Trd</a:t>
            </a:r>
            <a:r>
              <a:rPr b="1" lang="es-ES" sz="1100" spc="-1" strike="noStrike" baseline="-25000">
                <a:solidFill>
                  <a:srgbClr val="000000"/>
                </a:solidFill>
                <a:latin typeface="Calibri"/>
              </a:rPr>
              <a:t>o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330 CuadroTexto"/>
          <p:cNvSpPr/>
          <p:nvPr/>
        </p:nvSpPr>
        <p:spPr>
          <a:xfrm>
            <a:off x="4024440" y="3116160"/>
            <a:ext cx="476280" cy="19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Trd</a:t>
            </a:r>
            <a:r>
              <a:rPr b="1" lang="es-ES" sz="1100" spc="-1" strike="noStrike" baseline="-25000">
                <a:solidFill>
                  <a:srgbClr val="000000"/>
                </a:solidFill>
                <a:latin typeface="Calibri"/>
              </a:rPr>
              <a:t>r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8" name="55 Conector recto de flecha"/>
          <p:cNvCxnSpPr/>
          <p:nvPr/>
        </p:nvCxnSpPr>
        <p:spPr>
          <a:xfrm>
            <a:off x="2724120" y="3574800"/>
            <a:ext cx="9007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sm"/>
          </a:ln>
        </p:spPr>
      </p:cxnSp>
      <p:sp>
        <p:nvSpPr>
          <p:cNvPr id="59" name="194 Rectángulo"/>
          <p:cNvSpPr/>
          <p:nvPr/>
        </p:nvSpPr>
        <p:spPr>
          <a:xfrm>
            <a:off x="2452680" y="3575160"/>
            <a:ext cx="13096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100" spc="-1" strike="noStrike">
                <a:solidFill>
                  <a:srgbClr val="00b050"/>
                </a:solidFill>
                <a:latin typeface="Calibri"/>
              </a:rPr>
              <a:t>cys</a:t>
            </a:r>
            <a:r>
              <a:rPr b="1" lang="es-ES" sz="1100" spc="-1" strike="noStrike">
                <a:solidFill>
                  <a:srgbClr val="00b050"/>
                </a:solidFill>
                <a:latin typeface="Calibri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330 CuadroTexto"/>
          <p:cNvSpPr/>
          <p:nvPr/>
        </p:nvSpPr>
        <p:spPr>
          <a:xfrm>
            <a:off x="2462040" y="3476520"/>
            <a:ext cx="474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AP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1" name="58 Conector recto de flecha"/>
          <p:cNvCxnSpPr/>
          <p:nvPr/>
        </p:nvCxnSpPr>
        <p:spPr>
          <a:xfrm>
            <a:off x="1487520" y="3574800"/>
            <a:ext cx="9007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sm"/>
          </a:ln>
        </p:spPr>
      </p:cxnSp>
      <p:sp>
        <p:nvSpPr>
          <p:cNvPr id="62" name="194 Rectángulo"/>
          <p:cNvSpPr/>
          <p:nvPr/>
        </p:nvSpPr>
        <p:spPr>
          <a:xfrm>
            <a:off x="1262160" y="3575160"/>
            <a:ext cx="13096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100" spc="-1" strike="noStrike">
                <a:solidFill>
                  <a:srgbClr val="00b050"/>
                </a:solidFill>
                <a:latin typeface="Calibri"/>
              </a:rPr>
              <a:t>cys</a:t>
            </a:r>
            <a:r>
              <a:rPr b="1" lang="es-ES" sz="1100" spc="-1" strike="noStrike">
                <a:solidFill>
                  <a:srgbClr val="00b050"/>
                </a:solidFill>
                <a:latin typeface="Calibri"/>
              </a:rPr>
              <a:t>N  </a:t>
            </a:r>
            <a:r>
              <a:rPr b="1" i="1" lang="es-ES" sz="1100" spc="-1" strike="noStrike">
                <a:solidFill>
                  <a:srgbClr val="00b050"/>
                </a:solidFill>
                <a:latin typeface="Calibri"/>
              </a:rPr>
              <a:t>cys</a:t>
            </a:r>
            <a:r>
              <a:rPr b="1" lang="es-ES" sz="1100" spc="-1" strike="noStrike">
                <a:solidFill>
                  <a:srgbClr val="00b050"/>
                </a:solidFill>
                <a:latin typeface="Calibri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330 CuadroTexto"/>
          <p:cNvSpPr/>
          <p:nvPr/>
        </p:nvSpPr>
        <p:spPr>
          <a:xfrm>
            <a:off x="1058760" y="3476520"/>
            <a:ext cx="474840" cy="20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Calibri"/>
              </a:rPr>
              <a:t>SO</a:t>
            </a:r>
            <a:r>
              <a:rPr b="1" lang="en-US" sz="1200" spc="-1" strike="noStrike" baseline="-25000">
                <a:solidFill>
                  <a:srgbClr val="ff0000"/>
                </a:solidFill>
                <a:latin typeface="Calibri"/>
              </a:rPr>
              <a:t>4</a:t>
            </a:r>
            <a:r>
              <a:rPr b="1" lang="en-US" sz="1200" spc="-1" strike="noStrike" baseline="30000">
                <a:solidFill>
                  <a:srgbClr val="ff0000"/>
                </a:solidFill>
                <a:latin typeface="Calibri"/>
              </a:rPr>
              <a:t>2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330 CuadroTexto"/>
          <p:cNvSpPr/>
          <p:nvPr/>
        </p:nvSpPr>
        <p:spPr>
          <a:xfrm>
            <a:off x="1425600" y="2725560"/>
            <a:ext cx="474480" cy="52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AT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gt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1" lang="es-ES" sz="11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68 Arco"/>
          <p:cNvSpPr/>
          <p:nvPr/>
        </p:nvSpPr>
        <p:spPr>
          <a:xfrm flipH="1" flipV="1" rot="21369600">
            <a:off x="2830680" y="2583360"/>
            <a:ext cx="593640" cy="991800"/>
          </a:xfrm>
          <a:custGeom>
            <a:avLst/>
            <a:gdLst/>
            <a:ahLst/>
            <a:rect l="l" t="t" r="r" b="b"/>
            <a:pathLst>
              <a:path stroke="0" w="593866" h="993461">
                <a:moveTo>
                  <a:pt x="42858" y="239656"/>
                </a:moveTo>
                <a:cubicBezTo>
                  <a:pt x="103467" y="72020"/>
                  <a:pt x="217315" y="-20361"/>
                  <a:pt x="333534" y="3788"/>
                </a:cubicBezTo>
                <a:cubicBezTo>
                  <a:pt x="436592" y="25203"/>
                  <a:pt x="525474" y="135132"/>
                  <a:pt x="567925" y="293683"/>
                </a:cubicBezTo>
                <a:lnTo>
                  <a:pt x="296933" y="496731"/>
                </a:lnTo>
                <a:lnTo>
                  <a:pt x="42858" y="239656"/>
                </a:lnTo>
                <a:close/>
              </a:path>
              <a:path fill="none" w="593866" h="993461">
                <a:moveTo>
                  <a:pt x="42858" y="239656"/>
                </a:moveTo>
                <a:cubicBezTo>
                  <a:pt x="103467" y="72020"/>
                  <a:pt x="217315" y="-20361"/>
                  <a:pt x="333534" y="3788"/>
                </a:cubicBezTo>
                <a:cubicBezTo>
                  <a:pt x="436592" y="25203"/>
                  <a:pt x="525474" y="135132"/>
                  <a:pt x="567925" y="29368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102600" rIns="102600" tIns="51120" bIns="511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330 CuadroTexto"/>
          <p:cNvSpPr/>
          <p:nvPr/>
        </p:nvSpPr>
        <p:spPr>
          <a:xfrm>
            <a:off x="3124080" y="2949480"/>
            <a:ext cx="47484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AD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1" lang="es-ES" sz="1100" spc="-1" strike="noStrike" baseline="30000">
                <a:solidFill>
                  <a:srgbClr val="000000"/>
                </a:solidFill>
                <a:latin typeface="Calibri"/>
              </a:rPr>
              <a:t>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71 Arco"/>
          <p:cNvSpPr/>
          <p:nvPr/>
        </p:nvSpPr>
        <p:spPr>
          <a:xfrm flipH="1" flipV="1" rot="21369600">
            <a:off x="1623240" y="2583360"/>
            <a:ext cx="595440" cy="992160"/>
          </a:xfrm>
          <a:custGeom>
            <a:avLst/>
            <a:gdLst/>
            <a:ahLst/>
            <a:rect l="l" t="t" r="r" b="b"/>
            <a:pathLst>
              <a:path stroke="0" w="596074" h="993461">
                <a:moveTo>
                  <a:pt x="43272" y="238957"/>
                </a:moveTo>
                <a:cubicBezTo>
                  <a:pt x="104154" y="71811"/>
                  <a:pt x="218208" y="-20255"/>
                  <a:pt x="334641" y="3760"/>
                </a:cubicBezTo>
                <a:cubicBezTo>
                  <a:pt x="437990" y="25076"/>
                  <a:pt x="527169" y="134752"/>
                  <a:pt x="569868" y="293054"/>
                </a:cubicBezTo>
                <a:lnTo>
                  <a:pt x="298037" y="496731"/>
                </a:lnTo>
                <a:lnTo>
                  <a:pt x="43272" y="238957"/>
                </a:lnTo>
                <a:close/>
              </a:path>
              <a:path fill="none" w="596074" h="993461">
                <a:moveTo>
                  <a:pt x="43272" y="238957"/>
                </a:moveTo>
                <a:cubicBezTo>
                  <a:pt x="104154" y="71811"/>
                  <a:pt x="218208" y="-20255"/>
                  <a:pt x="334641" y="3760"/>
                </a:cubicBezTo>
                <a:cubicBezTo>
                  <a:pt x="437990" y="25076"/>
                  <a:pt x="527169" y="134752"/>
                  <a:pt x="569868" y="293054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102600" rIns="102600" tIns="51120" bIns="511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330 CuadroTexto"/>
          <p:cNvSpPr/>
          <p:nvPr/>
        </p:nvSpPr>
        <p:spPr>
          <a:xfrm>
            <a:off x="1952640" y="2725560"/>
            <a:ext cx="474480" cy="54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1" lang="es-ES" sz="1100" spc="-1" strike="noStrike" baseline="-25000">
                <a:solidFill>
                  <a:srgbClr val="000000"/>
                </a:solidFill>
                <a:latin typeface="Calibri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gd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PP</a:t>
            </a:r>
            <a:r>
              <a:rPr b="1" lang="es-ES" sz="1100" spc="-1" strike="noStrike" baseline="-25000">
                <a:solidFill>
                  <a:srgbClr val="000000"/>
                </a:solidFill>
                <a:latin typeface="Calibri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330 CuadroTexto"/>
          <p:cNvSpPr/>
          <p:nvPr/>
        </p:nvSpPr>
        <p:spPr>
          <a:xfrm>
            <a:off x="2749680" y="3116160"/>
            <a:ext cx="474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AT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76 Arco"/>
          <p:cNvSpPr/>
          <p:nvPr/>
        </p:nvSpPr>
        <p:spPr>
          <a:xfrm flipH="1" flipV="1" rot="21369600">
            <a:off x="4139640" y="2583720"/>
            <a:ext cx="596880" cy="992160"/>
          </a:xfrm>
          <a:custGeom>
            <a:avLst/>
            <a:gdLst/>
            <a:ahLst/>
            <a:rect l="l" t="t" r="r" b="b"/>
            <a:pathLst>
              <a:path stroke="0" w="596074" h="993461">
                <a:moveTo>
                  <a:pt x="43272" y="238957"/>
                </a:moveTo>
                <a:cubicBezTo>
                  <a:pt x="104154" y="71811"/>
                  <a:pt x="218208" y="-20255"/>
                  <a:pt x="334641" y="3760"/>
                </a:cubicBezTo>
                <a:cubicBezTo>
                  <a:pt x="437990" y="25076"/>
                  <a:pt x="527169" y="134752"/>
                  <a:pt x="569868" y="293054"/>
                </a:cubicBezTo>
                <a:lnTo>
                  <a:pt x="298037" y="496731"/>
                </a:lnTo>
                <a:lnTo>
                  <a:pt x="43272" y="238957"/>
                </a:lnTo>
                <a:close/>
              </a:path>
              <a:path fill="none" w="596074" h="993461">
                <a:moveTo>
                  <a:pt x="43272" y="238957"/>
                </a:moveTo>
                <a:cubicBezTo>
                  <a:pt x="104154" y="71811"/>
                  <a:pt x="218208" y="-20255"/>
                  <a:pt x="334641" y="3760"/>
                </a:cubicBezTo>
                <a:cubicBezTo>
                  <a:pt x="437990" y="25076"/>
                  <a:pt x="527169" y="134752"/>
                  <a:pt x="569868" y="293054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102600" rIns="102600" tIns="51120" bIns="511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194 Rectángulo"/>
          <p:cNvSpPr/>
          <p:nvPr/>
        </p:nvSpPr>
        <p:spPr>
          <a:xfrm>
            <a:off x="5460840" y="3575160"/>
            <a:ext cx="576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100" spc="-1" strike="noStrike">
                <a:solidFill>
                  <a:srgbClr val="00b050"/>
                </a:solidFill>
                <a:latin typeface="Calibri"/>
              </a:rPr>
              <a:t>cys</a:t>
            </a:r>
            <a:r>
              <a:rPr b="1" lang="es-ES" sz="1100" spc="-1" strike="noStrike">
                <a:solidFill>
                  <a:srgbClr val="00b050"/>
                </a:solidFill>
                <a:latin typeface="Calibri"/>
              </a:rPr>
              <a:t>I </a:t>
            </a:r>
            <a:r>
              <a:rPr b="1" i="1" lang="es-ES" sz="1100" spc="-1" strike="noStrike">
                <a:solidFill>
                  <a:srgbClr val="00b0f0"/>
                </a:solidFill>
                <a:latin typeface="Calibri"/>
              </a:rPr>
              <a:t>cys</a:t>
            </a:r>
            <a:r>
              <a:rPr b="1" lang="es-ES" sz="1100" spc="-1" strike="noStrike">
                <a:solidFill>
                  <a:srgbClr val="00b0f0"/>
                </a:solidFill>
                <a:latin typeface="Calibri"/>
              </a:rPr>
              <a:t>J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330 CuadroTexto"/>
          <p:cNvSpPr/>
          <p:nvPr/>
        </p:nvSpPr>
        <p:spPr>
          <a:xfrm>
            <a:off x="5100480" y="2978280"/>
            <a:ext cx="47484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Nadp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1" lang="es-ES" sz="1100" spc="-1" strike="noStrike" baseline="30000">
                <a:solidFill>
                  <a:srgbClr val="000000"/>
                </a:solidFill>
                <a:latin typeface="Calibri"/>
              </a:rPr>
              <a:t>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330 CuadroTexto"/>
          <p:cNvSpPr/>
          <p:nvPr/>
        </p:nvSpPr>
        <p:spPr>
          <a:xfrm>
            <a:off x="5748480" y="2970360"/>
            <a:ext cx="476280" cy="35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Nadp</a:t>
            </a:r>
            <a:r>
              <a:rPr b="1" lang="es-ES" sz="1100" spc="-1" strike="noStrike" baseline="30000">
                <a:solidFill>
                  <a:srgbClr val="000000"/>
                </a:solidFill>
                <a:latin typeface="Calibri"/>
              </a:rPr>
              <a:t>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1" lang="es-ES" sz="11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194 Rectángulo"/>
          <p:cNvSpPr/>
          <p:nvPr/>
        </p:nvSpPr>
        <p:spPr>
          <a:xfrm>
            <a:off x="6827760" y="3575160"/>
            <a:ext cx="540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100" spc="-1" strike="noStrike">
                <a:solidFill>
                  <a:srgbClr val="00b0f0"/>
                </a:solidFill>
                <a:latin typeface="Calibri"/>
              </a:rPr>
              <a:t>cys</a:t>
            </a:r>
            <a:r>
              <a:rPr b="1" lang="es-ES" sz="1100" spc="-1" strike="noStrike">
                <a:solidFill>
                  <a:srgbClr val="00b0f0"/>
                </a:solidFill>
                <a:latin typeface="Calibri"/>
              </a:rPr>
              <a:t>K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76 Arco"/>
          <p:cNvSpPr/>
          <p:nvPr/>
        </p:nvSpPr>
        <p:spPr>
          <a:xfrm flipH="1" flipV="1" rot="21369600">
            <a:off x="5407560" y="2584080"/>
            <a:ext cx="595440" cy="993960"/>
          </a:xfrm>
          <a:custGeom>
            <a:avLst/>
            <a:gdLst/>
            <a:ahLst/>
            <a:rect l="l" t="t" r="r" b="b"/>
            <a:pathLst>
              <a:path stroke="0" w="596074" h="993461">
                <a:moveTo>
                  <a:pt x="43272" y="238957"/>
                </a:moveTo>
                <a:cubicBezTo>
                  <a:pt x="104154" y="71811"/>
                  <a:pt x="218208" y="-20255"/>
                  <a:pt x="334641" y="3760"/>
                </a:cubicBezTo>
                <a:cubicBezTo>
                  <a:pt x="437990" y="25076"/>
                  <a:pt x="527169" y="134752"/>
                  <a:pt x="569868" y="293054"/>
                </a:cubicBezTo>
                <a:lnTo>
                  <a:pt x="298037" y="496731"/>
                </a:lnTo>
                <a:lnTo>
                  <a:pt x="43272" y="238957"/>
                </a:lnTo>
                <a:close/>
              </a:path>
              <a:path fill="none" w="596074" h="993461">
                <a:moveTo>
                  <a:pt x="43272" y="238957"/>
                </a:moveTo>
                <a:cubicBezTo>
                  <a:pt x="104154" y="71811"/>
                  <a:pt x="218208" y="-20255"/>
                  <a:pt x="334641" y="3760"/>
                </a:cubicBezTo>
                <a:cubicBezTo>
                  <a:pt x="437990" y="25076"/>
                  <a:pt x="527169" y="134752"/>
                  <a:pt x="569868" y="293054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102600" rIns="102600" tIns="51120" bIns="511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6" name="49 Conector recto de flecha"/>
          <p:cNvCxnSpPr/>
          <p:nvPr/>
        </p:nvCxnSpPr>
        <p:spPr>
          <a:xfrm>
            <a:off x="5326200" y="3573000"/>
            <a:ext cx="900720" cy="39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sm"/>
          </a:ln>
        </p:spPr>
      </p:cxnSp>
      <p:sp>
        <p:nvSpPr>
          <p:cNvPr id="77" name="76 Arco"/>
          <p:cNvSpPr/>
          <p:nvPr/>
        </p:nvSpPr>
        <p:spPr>
          <a:xfrm flipH="1" flipV="1" rot="21369600">
            <a:off x="6741000" y="2584440"/>
            <a:ext cx="596880" cy="993960"/>
          </a:xfrm>
          <a:custGeom>
            <a:avLst/>
            <a:gdLst/>
            <a:ahLst/>
            <a:rect l="l" t="t" r="r" b="b"/>
            <a:pathLst>
              <a:path stroke="0" w="596074" h="993461">
                <a:moveTo>
                  <a:pt x="43272" y="238957"/>
                </a:moveTo>
                <a:cubicBezTo>
                  <a:pt x="104154" y="71811"/>
                  <a:pt x="218208" y="-20255"/>
                  <a:pt x="334641" y="3760"/>
                </a:cubicBezTo>
                <a:cubicBezTo>
                  <a:pt x="437990" y="25076"/>
                  <a:pt x="527169" y="134752"/>
                  <a:pt x="569868" y="293054"/>
                </a:cubicBezTo>
                <a:lnTo>
                  <a:pt x="298037" y="496731"/>
                </a:lnTo>
                <a:lnTo>
                  <a:pt x="43272" y="238957"/>
                </a:lnTo>
                <a:close/>
              </a:path>
              <a:path fill="none" w="596074" h="993461">
                <a:moveTo>
                  <a:pt x="43272" y="238957"/>
                </a:moveTo>
                <a:cubicBezTo>
                  <a:pt x="104154" y="71811"/>
                  <a:pt x="218208" y="-20255"/>
                  <a:pt x="334641" y="3760"/>
                </a:cubicBezTo>
                <a:cubicBezTo>
                  <a:pt x="437990" y="25076"/>
                  <a:pt x="527169" y="134752"/>
                  <a:pt x="569868" y="293054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102600" rIns="102600" tIns="51120" bIns="511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8" name="49 Conector recto de flecha"/>
          <p:cNvCxnSpPr/>
          <p:nvPr/>
        </p:nvCxnSpPr>
        <p:spPr>
          <a:xfrm>
            <a:off x="6621480" y="3573000"/>
            <a:ext cx="900720" cy="39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sm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6T12:44:13Z</dcterms:created>
  <dc:creator>Carmen M. Gonzalez</dc:creator>
  <dc:description/>
  <dc:language>en-US</dc:language>
  <cp:lastModifiedBy>Juli  Pereto</cp:lastModifiedBy>
  <dcterms:modified xsi:type="dcterms:W3CDTF">2011-09-30T08:38:55Z</dcterms:modified>
  <cp:revision>42</cp:revision>
  <dc:subject/>
  <dc:title>Diapositiva 1</dc:title>
</cp:coreProperties>
</file>